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263515-6AD8-4EF7-A72C-F3BE2E2B61F4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034891-39B5-4ACB-BC6C-7A1A3C07817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73489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034891-39B5-4ACB-BC6C-7A1A3C078177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120171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BFED44-4B83-6DAC-31AD-A5D02F71C0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D253C8-5C12-019D-B1E6-2C043B3D0F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EA0C10-129C-6984-19E7-605E842B9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F1D90C-8A87-5A75-0936-4CC3DFBF8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DD04E6-649E-F3C0-3FB7-DB267B414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1301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15C31F-D08E-4091-97BD-B30CEDC710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B3ACCB-C7AD-D97F-666B-CA74B39997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8CDB04-721C-8FA9-3943-FDF96C41C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0B98E-23DD-D9D1-308B-E1DFAAB61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CAF77F-32B9-21B5-6A19-4941A2CE1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90616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60A58F-F65B-3EE5-42EF-238E39DFFD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2E13EF-0E24-BD75-B03F-7AB3F13834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0E7DD4-403E-221C-6CA4-B760C15C6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7381E4-7206-4AE6-532E-588A85815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B68319-AD28-D9C5-0E10-A0141E440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08025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FC9725-64F6-B666-8D8F-B04B80773F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06BE5F-A94A-79ED-D74A-F4F4CFD05F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80BF51-ACDD-B2DB-0DA2-19B4CB9A6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8C1757-224D-49A7-A1CD-43579C0A3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F9C28F-0C3F-6F92-C4BD-1510BA776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73321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0F5E96-B810-569C-1617-CD9FA6D060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EA4B19-BD1F-ADC8-8C53-C0CF45CB4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A60AE4-8175-0079-788E-218F67699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A94CEB-AF2A-E996-32AE-ECA1036EC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FC36C3-272F-53B5-3F3E-C37A07E50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96855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A3447B-D7B6-FCBF-65CB-F80FA4FC8B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A4F2CB-896D-576D-08BB-AED53DCD1A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E85CEE-743D-1D00-4836-6169457413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1C0E55-B543-A4A8-6DCB-4691C1644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F37F08-2588-5D31-B5BF-E1E948EC1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C77F3C-6000-C598-0907-C4658492C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0763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A141C0-7C72-C569-250E-88E3E33DD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35161C-3310-3C9E-722A-E66527F9C5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8C11AE-367A-C56A-F473-6003AA1D8E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13F082-3175-31E0-276B-6823EB457E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367F6B-5CD4-819E-DD84-214C49A0AB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088778-11FE-0F0B-AD90-B9C463F02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0F12F8-7392-B855-FB33-02CC13A2F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512C23-E1DA-2498-6BB0-5EA1874EB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13233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63BCC2-28D7-8316-B84A-8736CA7AC6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54D0A83-C640-9FB2-073B-ECD34E747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1F0B26D-7E39-C330-41BE-C946EB171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0A4A77-F04D-5B3E-9C20-0E9DD9232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2396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56E1C9-E8C0-25AF-ED06-C073EFB6E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D6F1E6-E93B-7FC4-077E-BF1651FAD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9FD0CF-C004-E746-DA5F-B7DBC59FE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7297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1C9A3-82F1-8941-D130-9E4991B911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0DF26F-5FA1-D0A4-9FBE-B747E3199B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DFD97A-61F7-12B7-8B86-069F2D0FB1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941EAC-36EF-F468-E13B-7BB69B007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D8C922-7DFD-6576-591D-68E9B9654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EE0E8F-947A-0ED4-A555-50D3F64C5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887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40AD30-56C4-4678-5212-55664F85F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275051-034E-EA9E-992E-B856EB59EA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1CC32E-15A3-05DE-3BAE-F88802D48F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C938C2-75E7-036C-83A2-EECDEF19A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C18466-AC53-69AE-9EC9-5E7676BC48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FC1248-0651-DBB0-A262-F911ABAF5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3194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EEFAB27-FD16-05AF-7A39-2354042C3E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7CCF67-1CD4-3567-830C-3783AB418E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0CF9E7-82F2-6688-9E34-4F700D4142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8D9728-4DB3-487F-A5D6-160A289494F0}" type="datetimeFigureOut">
              <a:rPr lang="en-IN" smtClean="0"/>
              <a:t>2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01C21E-E46A-3789-D980-E4CD9C8B8D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8E66F4-81DD-E6F4-DFA1-91F80283F6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92D7E-36DC-4B7E-AE9E-FE81991970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275746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406BD2-0A84-4CF7-6625-59F51E6DA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9437016" cy="558701"/>
          </a:xfrm>
        </p:spPr>
        <p:txBody>
          <a:bodyPr>
            <a:normAutofit fontScale="90000"/>
          </a:bodyPr>
          <a:lstStyle/>
          <a:p>
            <a:r>
              <a:rPr lang="en-IN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</a:t>
            </a:r>
            <a:r>
              <a:rPr lang="en-I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 of MS-PCR analysis</a:t>
            </a:r>
            <a:r>
              <a:rPr lang="en-I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inflammatory Cytokine Genes</a:t>
            </a:r>
            <a:endParaRPr lang="en-IN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0D6259-E27F-F721-20DD-10225A600A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62020" y="1253331"/>
            <a:ext cx="10515600" cy="435133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8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.TLR-2</a:t>
            </a:r>
            <a:endParaRPr lang="en-IN" sz="1800" dirty="0"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F6C8332-D80E-5DC0-4626-3C9E570390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17" y="1963692"/>
            <a:ext cx="3276001" cy="248067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1FEB6C5-AA95-EA08-E24B-64046FA51479}"/>
              </a:ext>
            </a:extLst>
          </p:cNvPr>
          <p:cNvSpPr txBox="1"/>
          <p:nvPr/>
        </p:nvSpPr>
        <p:spPr>
          <a:xfrm>
            <a:off x="3767762" y="1253331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. TLR-4</a:t>
            </a:r>
            <a:endParaRPr lang="en-IN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5EAAB1E1-3131-3A60-900D-262BE4F87D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67762" y="1963692"/>
            <a:ext cx="3577892" cy="248067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AB9926A-A603-8376-3C6E-63D71C75E5C4}"/>
              </a:ext>
            </a:extLst>
          </p:cNvPr>
          <p:cNvSpPr txBox="1"/>
          <p:nvPr/>
        </p:nvSpPr>
        <p:spPr>
          <a:xfrm>
            <a:off x="7883165" y="1253331"/>
            <a:ext cx="51541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. IFN-γ</a:t>
            </a:r>
            <a:endParaRPr lang="en-IN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6F05A758-DF3E-55E6-3514-3BD4293BA8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83165" y="1911115"/>
            <a:ext cx="3553042" cy="2585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08654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F9F6DF-3813-2B38-189F-2C3984FB86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6205D6-C7AF-81AC-98AF-EA657B2CD9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03096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50F05E0-6411-38F5-69D6-D5B1818F7F62}"/>
              </a:ext>
            </a:extLst>
          </p:cNvPr>
          <p:cNvSpPr txBox="1"/>
          <p:nvPr/>
        </p:nvSpPr>
        <p:spPr>
          <a:xfrm>
            <a:off x="483125" y="1474451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. TNF</a:t>
            </a:r>
            <a:r>
              <a:rPr lang="en-IN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α</a:t>
            </a:r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IN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56C66C3-8D6D-F8A9-CBDA-3E7C37EC3B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3125" y="2153765"/>
            <a:ext cx="3510531" cy="255046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2358D9E-F4D0-A936-28A5-1D6413FB4A22}"/>
              </a:ext>
            </a:extLst>
          </p:cNvPr>
          <p:cNvSpPr txBox="1"/>
          <p:nvPr/>
        </p:nvSpPr>
        <p:spPr>
          <a:xfrm>
            <a:off x="4291553" y="1474451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. IL</a:t>
            </a:r>
            <a:r>
              <a:rPr lang="en-IN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6 </a:t>
            </a:r>
            <a:endParaRPr lang="en-IN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7453EA5-548C-9036-50D5-21945EA4F2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47439" y="2153765"/>
            <a:ext cx="3510531" cy="256916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A0728ED-22F5-1C10-EBD7-F53AAFE8D8EC}"/>
              </a:ext>
            </a:extLst>
          </p:cNvPr>
          <p:cNvSpPr txBox="1"/>
          <p:nvPr/>
        </p:nvSpPr>
        <p:spPr>
          <a:xfrm>
            <a:off x="7892593" y="1474451"/>
            <a:ext cx="36929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. IL-1</a:t>
            </a:r>
            <a:r>
              <a:rPr lang="en-IN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endParaRPr lang="en-IN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F5DBAF3-7A0E-DCB6-017E-BDE0217337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11752" y="2141980"/>
            <a:ext cx="3692949" cy="26223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3759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B7DFBAC-C6CE-8870-E60E-2D49D2DF6DA8}"/>
              </a:ext>
            </a:extLst>
          </p:cNvPr>
          <p:cNvSpPr txBox="1"/>
          <p:nvPr/>
        </p:nvSpPr>
        <p:spPr>
          <a:xfrm>
            <a:off x="393171" y="1314195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. CXCL</a:t>
            </a:r>
            <a:r>
              <a:rPr lang="en-IN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 </a:t>
            </a:r>
            <a:endParaRPr lang="en-IN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0891A63-5063-93ED-D4F3-6320CF44E2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171" y="1950124"/>
            <a:ext cx="3648802" cy="252760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9C851F8-A9CB-81CF-2D90-C85408F5A4C5}"/>
              </a:ext>
            </a:extLst>
          </p:cNvPr>
          <p:cNvSpPr txBox="1"/>
          <p:nvPr/>
        </p:nvSpPr>
        <p:spPr>
          <a:xfrm>
            <a:off x="4225565" y="1314195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. FOXP-3</a:t>
            </a:r>
            <a:endParaRPr lang="en-IN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592ABEC8-9824-4720-134C-96D83B1901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1275" y="1950123"/>
            <a:ext cx="3673849" cy="252760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2B84D4E2-C154-BA6D-6758-792C1A7E8D84}"/>
              </a:ext>
            </a:extLst>
          </p:cNvPr>
          <p:cNvSpPr txBox="1"/>
          <p:nvPr/>
        </p:nvSpPr>
        <p:spPr>
          <a:xfrm>
            <a:off x="8222531" y="1318064"/>
            <a:ext cx="294823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. TGF</a:t>
            </a:r>
            <a:r>
              <a:rPr lang="en-IN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β</a:t>
            </a:r>
            <a:endParaRPr lang="en-IN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DC5E6F3-43AF-1824-BE72-D94878EC25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14426" y="1950123"/>
            <a:ext cx="3497502" cy="25276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45920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9E80F4DC-8217-5450-8040-D003E5754C7D}"/>
              </a:ext>
            </a:extLst>
          </p:cNvPr>
          <p:cNvSpPr txBox="1"/>
          <p:nvPr/>
        </p:nvSpPr>
        <p:spPr>
          <a:xfrm>
            <a:off x="1180708" y="122935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J. IL-10</a:t>
            </a:r>
            <a:endParaRPr lang="en-IN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99196EA-74FA-60C4-1F17-B1DDC9B2ED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0708" y="1672564"/>
            <a:ext cx="3733557" cy="29182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14821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7177FD-A130-9D63-BA28-13137622EE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8915FF-4C4E-73E6-8D1B-5AE68FA217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498423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0787C6-2414-651C-E8D7-7A5A26F262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AF9617-0B7D-24BC-EBF8-F7FB903E25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504894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230D40-E9D7-5FBF-EE10-A8CECDF93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C2EAF6-1A5C-53D7-FFF8-1C2C75C328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99622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2E806-8C2F-2C1E-0E17-39EBE0B81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5A668C-1814-5264-2A5C-10365B670D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52155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BC9363-D51C-8CC9-C8D4-BC4A4DE9F5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EE6F52-CC77-4907-5A0A-8C8BA748D8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1661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44</Words>
  <Application>Microsoft Office PowerPoint</Application>
  <PresentationFormat>Widescreen</PresentationFormat>
  <Paragraphs>12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Supplementary Figure 1: Representative result of MS-PCR analysis –inflammatory Cytokine Gen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nya sankar</dc:creator>
  <cp:lastModifiedBy>Saranya sankar</cp:lastModifiedBy>
  <cp:revision>4</cp:revision>
  <dcterms:created xsi:type="dcterms:W3CDTF">2025-04-28T02:47:04Z</dcterms:created>
  <dcterms:modified xsi:type="dcterms:W3CDTF">2025-04-28T03:24:44Z</dcterms:modified>
</cp:coreProperties>
</file>